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 autoAdjust="0"/>
    <p:restoredTop sz="94660"/>
  </p:normalViewPr>
  <p:slideViewPr>
    <p:cSldViewPr snapToGrid="0">
      <p:cViewPr varScale="1">
        <p:scale>
          <a:sx n="69" d="100"/>
          <a:sy n="69" d="100"/>
        </p:scale>
        <p:origin x="8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2E95D-7D0E-45CD-9385-EFCF48BDDA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50289E-0F4D-40E1-AAE2-C37E43E41B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1FAC86-6B5B-44B1-9461-D0D2407D9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C3C6FC-2005-4A80-A908-13093052E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7B8688-1E2E-45DF-86D0-A971837FC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61845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67751-0C09-4B8E-8EBD-663A63B25C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74E280-6955-4998-9F01-027D719C37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D46AEF-8B61-460D-B87A-4D3B79584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B27D6-4394-4C33-82FE-F66C40B5A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7CDB0-3261-4977-AB4E-F7E05E336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73878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727DF1-184D-42DB-9A38-2C631CFCEB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C9D7B4-7994-411F-9FF6-DE15D5CB1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87A8E0-4C94-4D31-8DCE-19054D43D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694CBE-58F6-4DD8-95C5-25DA7C73F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AF4865-C21B-42F7-A054-E7026B69A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89750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433BF-35BA-411E-AE63-FEB5B57B6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56DF18-5ABC-42FB-8997-499CC686B0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550DBB-7A85-4F70-B8D8-9545D92FE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FBCB79-EC92-4D86-B11E-150B1B8AF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B7C5DB-9A64-417B-950E-4DB924453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61136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F05BE1-80DE-4EF1-AC13-89AE7A3FF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4340A3-61AB-45B2-8652-259CA6F6CE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2B8EB7-2DC9-4086-8ACF-29ED4AE9F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28AE4F-706D-4B41-89CA-25DD72612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9EF5A-A668-4C58-8122-E6281601C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46206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24EFC-5993-4DC8-9DE5-148F29EAB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10383A-F188-48B8-92DB-8DFA3A566E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C73623-7CC6-4AC1-A65B-136930CD9D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2A93CB-CFA0-4050-83F3-E133DCC4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1B43BC-3A4A-42D0-983A-7352A5D5B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1B41D0-E42A-4D7C-A33C-F37277AAC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49888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2EF22-C853-4477-8D21-7202FC250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9CC2AA-B107-4B40-9FAB-56F79ED67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85FBDB-4187-4A32-BD68-8D33800A5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D1F1BF-782F-4577-AEA4-F2DD119CD7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F711D3-FD24-4FDF-B7A0-8EE292F882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BC9F81-EC4F-4A8B-A90F-149805A4A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AA2332-C172-461B-9F99-AFE59F69E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E39DBF-7A2D-4C13-9622-9A1D041A7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3365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3640B9-4E7A-4C33-8EE0-E1F2DCC3BF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56FA9D-B2DF-4F37-AF66-9E6C153DF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03DE1B-52EC-4031-9807-E1CEC75F5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9C639B-6288-4C3A-B6C0-448769EF6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4600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FCE59E-992E-4F3A-B782-31BB410FE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F49957-F6CB-4B3B-A3FC-9DBE831EE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B17B19-2224-4FF6-ACC6-C7DB45E98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22920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681F8C-17B8-4CFF-A307-4D9AEB0D4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D3CDD2-3D2B-4780-AE49-B1B142AFBE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585480-B73B-446F-A680-392A2F36D8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97C6C9-C387-4BE7-B316-43E3D9441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27ADC2-0BCB-46B4-8370-D46FD1C26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409C8B-2C84-487F-B9D4-CBB9FE73B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67113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FB667-D713-4876-AA7A-D4ABC4ABF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59B605-E3C4-405C-8FC3-BF36351353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97FCDF-C8C2-4093-A703-6F130868C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98C96F-31ED-49FD-BC84-B2AEF694F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DDBDF6-19E1-459B-9907-EE92E8E3A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359B0B-B22B-48DE-ACA1-DFE9AA66F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62882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A9FF35-7DED-46D9-89B2-228FDCDF6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3F25B6-2E8F-47D7-9E9D-78734D01D7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8DD202-B42B-41D1-8D2E-D861E4C645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4D521-3686-43C8-9EDA-8250551D3A63}" type="datetimeFigureOut">
              <a:rPr lang="en-IE" smtClean="0"/>
              <a:t>22/03/2021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63B991-57BE-4DB3-93B2-7A74607F45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DCEDDF-22F7-4C8D-BBFA-B8055371A7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B410A-CF92-41EC-BA4B-B42F10354CB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6967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21">
            <a:extLst>
              <a:ext uri="{FF2B5EF4-FFF2-40B4-BE49-F238E27FC236}">
                <a16:creationId xmlns:a16="http://schemas.microsoft.com/office/drawing/2014/main" id="{F5CB835A-6A79-4904-BD93-262A6DFDF5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8206" y="6232872"/>
            <a:ext cx="10781732" cy="7879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lnSpc>
                <a:spcPct val="100000"/>
              </a:lnSpc>
              <a:spcBef>
                <a:spcPct val="0"/>
              </a:spcBef>
              <a:buNone/>
            </a:pPr>
            <a:r>
              <a:rPr lang="en-IE" altLang="en-US" sz="1130" dirty="0">
                <a:latin typeface="+mn-lt"/>
              </a:rPr>
              <a:t>Figure S2: Nucleotide a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lignment of the partial </a:t>
            </a:r>
            <a:r>
              <a:rPr lang="en-IE" sz="1130" i="1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sMLO 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andidate (AsMLO1_c) that was cloned using primers based on the </a:t>
            </a:r>
            <a:r>
              <a:rPr lang="en-IE" sz="1130" i="1" dirty="0" err="1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vena</a:t>
            </a:r>
            <a:r>
              <a:rPr lang="en-IE" sz="1130" i="1" dirty="0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barbata, HvMLO </a:t>
            </a:r>
            <a:r>
              <a:rPr lang="en-IE" sz="1130" dirty="0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IE" sz="1130" i="1" dirty="0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TaMLO 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sequences. Alignment was performed using Multalin (v5.4.1) and visualized using </a:t>
            </a:r>
            <a:r>
              <a:rPr lang="en-IE" sz="1130" dirty="0" err="1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ESPrint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software. </a:t>
            </a:r>
            <a:r>
              <a:rPr lang="en-IE" sz="1130" dirty="0" err="1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Genbank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accession numbers of  </a:t>
            </a:r>
            <a:r>
              <a:rPr lang="en-IE" sz="1130" i="1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MLO 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nucleotide sequences used in alignment: </a:t>
            </a:r>
            <a:r>
              <a:rPr lang="en-IE" sz="1130" i="1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. barbata 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(GR359758.1); </a:t>
            </a:r>
            <a:r>
              <a:rPr lang="en-IE" sz="1130" i="1" dirty="0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HvMLO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(Z83834.1); and </a:t>
            </a:r>
            <a:r>
              <a:rPr lang="en-IE" sz="1130" i="1" dirty="0">
                <a:solidFill>
                  <a:srgbClr val="000000"/>
                </a:solidFill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TaMLO</a:t>
            </a:r>
            <a:r>
              <a:rPr lang="en-IE" sz="1130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 (AF384144.1).</a:t>
            </a:r>
            <a:endParaRPr lang="en-IE" sz="1130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IE" altLang="en-US" sz="1130" dirty="0">
              <a:latin typeface="+mn-lt"/>
            </a:endParaRPr>
          </a:p>
        </p:txBody>
      </p:sp>
      <p:pic>
        <p:nvPicPr>
          <p:cNvPr id="8" name="Picture 7" descr="Table&#10;&#10;Description automatically generated">
            <a:extLst>
              <a:ext uri="{FF2B5EF4-FFF2-40B4-BE49-F238E27FC236}">
                <a16:creationId xmlns:a16="http://schemas.microsoft.com/office/drawing/2014/main" id="{2969C936-BE2A-4B16-8EF0-10B8E99BDDB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1"/>
          <a:stretch/>
        </p:blipFill>
        <p:spPr>
          <a:xfrm>
            <a:off x="1280556" y="0"/>
            <a:ext cx="10077031" cy="6232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5437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14</TotalTime>
  <Words>7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sling Reilly</dc:creator>
  <cp:lastModifiedBy>Angela</cp:lastModifiedBy>
  <cp:revision>29</cp:revision>
  <dcterms:created xsi:type="dcterms:W3CDTF">2021-03-12T09:58:29Z</dcterms:created>
  <dcterms:modified xsi:type="dcterms:W3CDTF">2021-03-22T17:04:06Z</dcterms:modified>
</cp:coreProperties>
</file>